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96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796282325219677"/>
          <c:y val="7.4760548464649135E-2"/>
          <c:w val="0.66867828639195126"/>
          <c:h val="0.7350126611467197"/>
        </c:manualLayout>
      </c:layout>
      <c:lineChart>
        <c:grouping val="standard"/>
        <c:varyColors val="0"/>
        <c:ser>
          <c:idx val="0"/>
          <c:order val="0"/>
          <c:tx>
            <c:strRef>
              <c:f>'Figures of P.c'!$K$1</c:f>
              <c:strCache>
                <c:ptCount val="1"/>
                <c:pt idx="0">
                  <c:v>Fungus growth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s of P.c'!$K$14:$K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8.7538562930859225</c:v>
                  </c:pt>
                  <c:pt idx="2">
                    <c:v>1.1269427669584642</c:v>
                  </c:pt>
                  <c:pt idx="3">
                    <c:v>5.8847259919218082</c:v>
                  </c:pt>
                  <c:pt idx="4">
                    <c:v>8.6087165129304015</c:v>
                  </c:pt>
                  <c:pt idx="5">
                    <c:v>7.813663246732184</c:v>
                  </c:pt>
                  <c:pt idx="6">
                    <c:v>9.5911417464241335</c:v>
                  </c:pt>
                  <c:pt idx="7">
                    <c:v>22.85373784161651</c:v>
                  </c:pt>
                  <c:pt idx="8">
                    <c:v>7.4665922615340694</c:v>
                  </c:pt>
                  <c:pt idx="9">
                    <c:v>14.205984654363085</c:v>
                  </c:pt>
                  <c:pt idx="10">
                    <c:v>22.727589694759388</c:v>
                  </c:pt>
                </c:numCache>
              </c:numRef>
            </c:plus>
            <c:minus>
              <c:numRef>
                <c:f>'Figures of P.c'!$K$14:$K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8.7538562930859225</c:v>
                  </c:pt>
                  <c:pt idx="2">
                    <c:v>1.1269427669584642</c:v>
                  </c:pt>
                  <c:pt idx="3">
                    <c:v>5.8847259919218082</c:v>
                  </c:pt>
                  <c:pt idx="4">
                    <c:v>8.6087165129304015</c:v>
                  </c:pt>
                  <c:pt idx="5">
                    <c:v>7.813663246732184</c:v>
                  </c:pt>
                  <c:pt idx="6">
                    <c:v>9.5911417464241335</c:v>
                  </c:pt>
                  <c:pt idx="7">
                    <c:v>22.85373784161651</c:v>
                  </c:pt>
                  <c:pt idx="8">
                    <c:v>7.4665922615340694</c:v>
                  </c:pt>
                  <c:pt idx="9">
                    <c:v>14.205984654363085</c:v>
                  </c:pt>
                  <c:pt idx="10">
                    <c:v>22.727589694759388</c:v>
                  </c:pt>
                </c:numCache>
              </c:numRef>
            </c:minus>
          </c:errBars>
          <c:cat>
            <c:numRef>
              <c:f>'Figures of P.c'!$J$2:$J$12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Figures of P.c'!$K$2:$K$12</c:f>
              <c:numCache>
                <c:formatCode>General</c:formatCode>
                <c:ptCount val="11"/>
                <c:pt idx="0">
                  <c:v>0</c:v>
                </c:pt>
                <c:pt idx="1">
                  <c:v>16.8</c:v>
                </c:pt>
                <c:pt idx="2">
                  <c:v>34.4</c:v>
                </c:pt>
                <c:pt idx="3">
                  <c:v>47.1</c:v>
                </c:pt>
                <c:pt idx="4">
                  <c:v>56.9</c:v>
                </c:pt>
                <c:pt idx="5">
                  <c:v>63.966666666666669</c:v>
                </c:pt>
                <c:pt idx="6">
                  <c:v>56.5</c:v>
                </c:pt>
                <c:pt idx="7">
                  <c:v>51.43333333333333</c:v>
                </c:pt>
                <c:pt idx="8">
                  <c:v>47.79999999999999</c:v>
                </c:pt>
                <c:pt idx="9">
                  <c:v>72.900000000000006</c:v>
                </c:pt>
                <c:pt idx="10">
                  <c:v>61.633333333333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241088"/>
        <c:axId val="45243008"/>
      </c:lineChart>
      <c:lineChart>
        <c:grouping val="standard"/>
        <c:varyColors val="0"/>
        <c:ser>
          <c:idx val="1"/>
          <c:order val="1"/>
          <c:tx>
            <c:strRef>
              <c:f>'Figures of P.c'!$L$1</c:f>
              <c:strCache>
                <c:ptCount val="1"/>
                <c:pt idx="0">
                  <c:v>pH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s of P.c'!$L$14:$L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5.727419430540532E-2</c:v>
                  </c:pt>
                  <c:pt idx="2">
                    <c:v>1.4224392195567981E-2</c:v>
                  </c:pt>
                  <c:pt idx="3">
                    <c:v>3.9509492530276691E-2</c:v>
                  </c:pt>
                  <c:pt idx="4">
                    <c:v>5.4808758424178892E-2</c:v>
                  </c:pt>
                  <c:pt idx="5">
                    <c:v>7.3663650013648649E-2</c:v>
                  </c:pt>
                  <c:pt idx="6">
                    <c:v>4.2579337712087405E-2</c:v>
                  </c:pt>
                  <c:pt idx="7">
                    <c:v>0.10626539104211377</c:v>
                  </c:pt>
                  <c:pt idx="8">
                    <c:v>1.7616280348965192E-2</c:v>
                  </c:pt>
                  <c:pt idx="9">
                    <c:v>4.5368858629387283E-2</c:v>
                  </c:pt>
                  <c:pt idx="10">
                    <c:v>1.9974984355438069E-2</c:v>
                  </c:pt>
                </c:numCache>
              </c:numRef>
            </c:plus>
            <c:minus>
              <c:numRef>
                <c:f>'Figures of P.c'!$L$14:$L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5.727419430540532E-2</c:v>
                  </c:pt>
                  <c:pt idx="2">
                    <c:v>1.4224392195567981E-2</c:v>
                  </c:pt>
                  <c:pt idx="3">
                    <c:v>3.9509492530276691E-2</c:v>
                  </c:pt>
                  <c:pt idx="4">
                    <c:v>5.4808758424178892E-2</c:v>
                  </c:pt>
                  <c:pt idx="5">
                    <c:v>7.3663650013648649E-2</c:v>
                  </c:pt>
                  <c:pt idx="6">
                    <c:v>4.2579337712087405E-2</c:v>
                  </c:pt>
                  <c:pt idx="7">
                    <c:v>0.10626539104211377</c:v>
                  </c:pt>
                  <c:pt idx="8">
                    <c:v>1.7616280348965192E-2</c:v>
                  </c:pt>
                  <c:pt idx="9">
                    <c:v>4.5368858629387283E-2</c:v>
                  </c:pt>
                  <c:pt idx="10">
                    <c:v>1.9974984355438069E-2</c:v>
                  </c:pt>
                </c:numCache>
              </c:numRef>
            </c:minus>
          </c:errBars>
          <c:cat>
            <c:numRef>
              <c:f>'Figures of P.c'!$J$2:$J$12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Figures of P.c'!$L$2:$L$12</c:f>
              <c:numCache>
                <c:formatCode>General</c:formatCode>
                <c:ptCount val="11"/>
                <c:pt idx="0">
                  <c:v>4.5</c:v>
                </c:pt>
                <c:pt idx="1">
                  <c:v>4.8593333333333337</c:v>
                </c:pt>
                <c:pt idx="2">
                  <c:v>4.0826666666666673</c:v>
                </c:pt>
                <c:pt idx="3">
                  <c:v>3.9019999999999997</c:v>
                </c:pt>
                <c:pt idx="4">
                  <c:v>3.8699999999999997</c:v>
                </c:pt>
                <c:pt idx="5">
                  <c:v>3.8956666666666671</c:v>
                </c:pt>
                <c:pt idx="6">
                  <c:v>3.9060000000000001</c:v>
                </c:pt>
                <c:pt idx="7">
                  <c:v>3.9653333333333336</c:v>
                </c:pt>
                <c:pt idx="8">
                  <c:v>3.9243333333333332</c:v>
                </c:pt>
                <c:pt idx="9">
                  <c:v>3.9803333333333337</c:v>
                </c:pt>
                <c:pt idx="10">
                  <c:v>4.00600000000000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267200"/>
        <c:axId val="45265664"/>
      </c:lineChart>
      <c:dateAx>
        <c:axId val="452410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Incubation time (day)</a:t>
                </a:r>
                <a:endParaRPr lang="zh-CN"/>
              </a:p>
            </c:rich>
          </c:tx>
          <c:layout/>
          <c:overlay val="0"/>
        </c:title>
        <c:numFmt formatCode="General" sourceLinked="1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crossAx val="45243008"/>
        <c:crosses val="autoZero"/>
        <c:auto val="0"/>
        <c:lblOffset val="100"/>
        <c:baseTimeUnit val="days"/>
        <c:majorUnit val="2"/>
      </c:dateAx>
      <c:valAx>
        <c:axId val="45243008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ycelial dry weights (mg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7.4991372938395168E-2"/>
              <c:y val="0.1425582883389325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crossAx val="45241088"/>
        <c:crosses val="autoZero"/>
        <c:crossBetween val="midCat"/>
        <c:majorUnit val="20"/>
      </c:valAx>
      <c:valAx>
        <c:axId val="45265664"/>
        <c:scaling>
          <c:orientation val="minMax"/>
          <c:max val="6"/>
          <c:min val="2"/>
        </c:scaling>
        <c:delete val="0"/>
        <c:axPos val="r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crossAx val="45267200"/>
        <c:crosses val="max"/>
        <c:crossBetween val="between"/>
        <c:majorUnit val="1"/>
      </c:valAx>
      <c:catAx>
        <c:axId val="4526720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5265664"/>
        <c:crosses val="autoZero"/>
        <c:auto val="1"/>
        <c:lblAlgn val="ctr"/>
        <c:lblOffset val="100"/>
        <c:noMultiLvlLbl val="0"/>
      </c:cat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09951881014873"/>
          <c:y val="5.1400554097404488E-2"/>
          <c:w val="0.72123140857392831"/>
          <c:h val="0.73076771653543304"/>
        </c:manualLayout>
      </c:layout>
      <c:lineChart>
        <c:grouping val="standard"/>
        <c:varyColors val="0"/>
        <c:ser>
          <c:idx val="0"/>
          <c:order val="0"/>
          <c:tx>
            <c:strRef>
              <c:f>'Figures of MG-60'!$K$1</c:f>
              <c:strCache>
                <c:ptCount val="1"/>
                <c:pt idx="0">
                  <c:v>Fungus growth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s of MG-60'!$K$14:$K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.5716233645501709</c:v>
                  </c:pt>
                  <c:pt idx="2">
                    <c:v>1.7616280348965083</c:v>
                  </c:pt>
                  <c:pt idx="3">
                    <c:v>1.7039170558842751</c:v>
                  </c:pt>
                  <c:pt idx="4">
                    <c:v>3.2929217016706214</c:v>
                  </c:pt>
                  <c:pt idx="5">
                    <c:v>6.6775744099186305</c:v>
                  </c:pt>
                  <c:pt idx="6">
                    <c:v>8.826286497351715</c:v>
                  </c:pt>
                  <c:pt idx="7">
                    <c:v>11.351798682734522</c:v>
                  </c:pt>
                  <c:pt idx="8">
                    <c:v>6.7884706181387946</c:v>
                  </c:pt>
                  <c:pt idx="9">
                    <c:v>0.47258156262526019</c:v>
                  </c:pt>
                  <c:pt idx="10">
                    <c:v>1.9672315572905994</c:v>
                  </c:pt>
                </c:numCache>
              </c:numRef>
            </c:plus>
            <c:minus>
              <c:numRef>
                <c:f>'Figures of MG-60'!$K$14:$K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.5716233645501709</c:v>
                  </c:pt>
                  <c:pt idx="2">
                    <c:v>1.7616280348965083</c:v>
                  </c:pt>
                  <c:pt idx="3">
                    <c:v>1.7039170558842751</c:v>
                  </c:pt>
                  <c:pt idx="4">
                    <c:v>3.2929217016706214</c:v>
                  </c:pt>
                  <c:pt idx="5">
                    <c:v>6.6775744099186305</c:v>
                  </c:pt>
                  <c:pt idx="6">
                    <c:v>8.826286497351715</c:v>
                  </c:pt>
                  <c:pt idx="7">
                    <c:v>11.351798682734522</c:v>
                  </c:pt>
                  <c:pt idx="8">
                    <c:v>6.7884706181387946</c:v>
                  </c:pt>
                  <c:pt idx="9">
                    <c:v>0.47258156262526019</c:v>
                  </c:pt>
                  <c:pt idx="10">
                    <c:v>1.9672315572905994</c:v>
                  </c:pt>
                </c:numCache>
              </c:numRef>
            </c:minus>
          </c:errBars>
          <c:cat>
            <c:numRef>
              <c:f>'Figures of MG-60'!$J$2:$J$12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Figures of MG-60'!$K$2:$K$12</c:f>
              <c:numCache>
                <c:formatCode>General</c:formatCode>
                <c:ptCount val="11"/>
                <c:pt idx="0">
                  <c:v>0</c:v>
                </c:pt>
                <c:pt idx="1">
                  <c:v>14.200000000000001</c:v>
                </c:pt>
                <c:pt idx="2">
                  <c:v>25.266666666666666</c:v>
                </c:pt>
                <c:pt idx="3">
                  <c:v>23.633333333333336</c:v>
                </c:pt>
                <c:pt idx="4">
                  <c:v>29.433333333333337</c:v>
                </c:pt>
                <c:pt idx="5">
                  <c:v>21.2</c:v>
                </c:pt>
                <c:pt idx="6">
                  <c:v>38.766666666666666</c:v>
                </c:pt>
                <c:pt idx="7">
                  <c:v>33.233333333333334</c:v>
                </c:pt>
                <c:pt idx="8">
                  <c:v>32.566666666666663</c:v>
                </c:pt>
                <c:pt idx="9">
                  <c:v>25.966666666666669</c:v>
                </c:pt>
                <c:pt idx="10">
                  <c:v>26.5999999999999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128192"/>
        <c:axId val="49130112"/>
      </c:lineChart>
      <c:lineChart>
        <c:grouping val="standard"/>
        <c:varyColors val="0"/>
        <c:ser>
          <c:idx val="1"/>
          <c:order val="1"/>
          <c:tx>
            <c:strRef>
              <c:f>'Figures of MG-60'!$L$1</c:f>
              <c:strCache>
                <c:ptCount val="1"/>
                <c:pt idx="0">
                  <c:v>pH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s of MG-60'!$L$14:$L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3.0072135496724054E-2</c:v>
                  </c:pt>
                  <c:pt idx="2">
                    <c:v>1.2662279942148417E-2</c:v>
                  </c:pt>
                  <c:pt idx="3">
                    <c:v>1.8770544300401433E-2</c:v>
                  </c:pt>
                  <c:pt idx="4">
                    <c:v>4.012895878705737E-2</c:v>
                  </c:pt>
                  <c:pt idx="5">
                    <c:v>2.5709920264364729E-2</c:v>
                  </c:pt>
                  <c:pt idx="6">
                    <c:v>6.1272614872660079E-2</c:v>
                  </c:pt>
                  <c:pt idx="7">
                    <c:v>7.0436732841134539E-2</c:v>
                  </c:pt>
                  <c:pt idx="8">
                    <c:v>3.0446674695276697E-2</c:v>
                  </c:pt>
                  <c:pt idx="9">
                    <c:v>7.7674534651539168E-3</c:v>
                  </c:pt>
                  <c:pt idx="10">
                    <c:v>2.2590558499809857E-2</c:v>
                  </c:pt>
                </c:numCache>
              </c:numRef>
            </c:plus>
            <c:minus>
              <c:numRef>
                <c:f>'Figures of MG-60'!$L$14:$L$24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3.0072135496724054E-2</c:v>
                  </c:pt>
                  <c:pt idx="2">
                    <c:v>1.2662279942148417E-2</c:v>
                  </c:pt>
                  <c:pt idx="3">
                    <c:v>1.8770544300401433E-2</c:v>
                  </c:pt>
                  <c:pt idx="4">
                    <c:v>4.012895878705737E-2</c:v>
                  </c:pt>
                  <c:pt idx="5">
                    <c:v>2.5709920264364729E-2</c:v>
                  </c:pt>
                  <c:pt idx="6">
                    <c:v>6.1272614872660079E-2</c:v>
                  </c:pt>
                  <c:pt idx="7">
                    <c:v>7.0436732841134539E-2</c:v>
                  </c:pt>
                  <c:pt idx="8">
                    <c:v>3.0446674695276697E-2</c:v>
                  </c:pt>
                  <c:pt idx="9">
                    <c:v>7.7674534651539168E-3</c:v>
                  </c:pt>
                  <c:pt idx="10">
                    <c:v>2.2590558499809857E-2</c:v>
                  </c:pt>
                </c:numCache>
              </c:numRef>
            </c:minus>
          </c:errBars>
          <c:cat>
            <c:numRef>
              <c:f>'Figures of MG-60'!$J$2:$J$12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Figures of MG-60'!$L$2:$L$12</c:f>
              <c:numCache>
                <c:formatCode>General</c:formatCode>
                <c:ptCount val="11"/>
                <c:pt idx="0">
                  <c:v>4.5</c:v>
                </c:pt>
                <c:pt idx="1">
                  <c:v>4.5976666666666661</c:v>
                </c:pt>
                <c:pt idx="2">
                  <c:v>3.8896666666666668</c:v>
                </c:pt>
                <c:pt idx="3">
                  <c:v>3.8983333333333334</c:v>
                </c:pt>
                <c:pt idx="4">
                  <c:v>3.9236666666666671</c:v>
                </c:pt>
                <c:pt idx="5">
                  <c:v>4.048</c:v>
                </c:pt>
                <c:pt idx="6">
                  <c:v>3.956666666666667</c:v>
                </c:pt>
                <c:pt idx="7">
                  <c:v>4.0403333333333338</c:v>
                </c:pt>
                <c:pt idx="8">
                  <c:v>3.9689999999999999</c:v>
                </c:pt>
                <c:pt idx="9">
                  <c:v>4.0893333333333333</c:v>
                </c:pt>
                <c:pt idx="10">
                  <c:v>4.053666666666667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142016"/>
        <c:axId val="49140480"/>
      </c:lineChart>
      <c:dateAx>
        <c:axId val="49128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Incubation time (</a:t>
                </a:r>
                <a:r>
                  <a:rPr lang="en-US" dirty="0" smtClean="0"/>
                  <a:t>day)</a:t>
                </a:r>
                <a:endParaRPr lang="zh-CN" dirty="0"/>
              </a:p>
            </c:rich>
          </c:tx>
          <c:layout/>
          <c:overlay val="0"/>
        </c:title>
        <c:numFmt formatCode="General" sourceLinked="1"/>
        <c:majorTickMark val="in"/>
        <c:minorTickMark val="in"/>
        <c:tickLblPos val="nextTo"/>
        <c:spPr>
          <a:ln>
            <a:solidFill>
              <a:sysClr val="windowText" lastClr="000000"/>
            </a:solidFill>
          </a:ln>
        </c:spPr>
        <c:crossAx val="49130112"/>
        <c:crosses val="autoZero"/>
        <c:auto val="0"/>
        <c:lblOffset val="100"/>
        <c:baseTimeUnit val="days"/>
        <c:majorUnit val="2"/>
      </c:dateAx>
      <c:valAx>
        <c:axId val="49130112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ycelial dry weights (mg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9.205738733015523E-3"/>
              <c:y val="0.10977849455287496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49128192"/>
        <c:crosses val="autoZero"/>
        <c:crossBetween val="midCat"/>
        <c:majorUnit val="20"/>
      </c:valAx>
      <c:valAx>
        <c:axId val="49140480"/>
        <c:scaling>
          <c:orientation val="minMax"/>
          <c:max val="6"/>
          <c:min val="2"/>
        </c:scaling>
        <c:delete val="0"/>
        <c:axPos val="r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crossAx val="49142016"/>
        <c:crosses val="max"/>
        <c:crossBetween val="between"/>
        <c:majorUnit val="1"/>
      </c:valAx>
      <c:catAx>
        <c:axId val="491420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9140480"/>
        <c:crosses val="autoZero"/>
        <c:auto val="1"/>
        <c:lblAlgn val="ctr"/>
        <c:lblOffset val="100"/>
        <c:noMultiLvlLbl val="0"/>
      </c:cat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1757</cdr:x>
      <cdr:y>0.25585</cdr:y>
    </cdr:from>
    <cdr:to>
      <cdr:x>0.97398</cdr:x>
      <cdr:y>0.51124</cdr:y>
    </cdr:to>
    <cdr:sp macro="" textlink="">
      <cdr:nvSpPr>
        <cdr:cNvPr id="2" name="TextBox 4"/>
        <cdr:cNvSpPr txBox="1"/>
      </cdr:nvSpPr>
      <cdr:spPr>
        <a:xfrm xmlns:a="http://schemas.openxmlformats.org/drawingml/2006/main" rot="5400000" flipH="1" flipV="1">
          <a:off x="2629401" y="810867"/>
          <a:ext cx="598075" cy="174665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900" b="1" dirty="0">
              <a:latin typeface="Arial" panose="020B0604020202020204" pitchFamily="34" charset="0"/>
              <a:cs typeface="Arial" panose="020B0604020202020204" pitchFamily="34" charset="0"/>
            </a:rPr>
            <a:t>pH</a:t>
          </a:r>
          <a:endParaRPr lang="zh-CN" altLang="en-US" sz="9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90675</cdr:x>
      <cdr:y>0.21123</cdr:y>
    </cdr:from>
    <cdr:to>
      <cdr:x>0.96203</cdr:x>
      <cdr:y>0.47538</cdr:y>
    </cdr:to>
    <cdr:sp macro="" textlink="">
      <cdr:nvSpPr>
        <cdr:cNvPr id="2" name="TextBox 4"/>
        <cdr:cNvSpPr txBox="1"/>
      </cdr:nvSpPr>
      <cdr:spPr>
        <a:xfrm xmlns:a="http://schemas.openxmlformats.org/drawingml/2006/main" rot="5400000" flipH="1" flipV="1">
          <a:off x="2836862" y="741042"/>
          <a:ext cx="642053" cy="186826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900" b="1" dirty="0">
              <a:latin typeface="Arial" panose="020B0604020202020204" pitchFamily="34" charset="0"/>
              <a:cs typeface="Arial" panose="020B0604020202020204" pitchFamily="34" charset="0"/>
            </a:rPr>
            <a:t>pH</a:t>
          </a:r>
          <a:endParaRPr lang="zh-CN" altLang="en-US" sz="9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945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4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56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979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223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067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349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1329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484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931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7934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2E0843-78A0-4669-95A6-B8AD4D1B0F07}" type="datetimeFigureOut">
              <a:rPr kumimoji="1" lang="ja-JP" altLang="en-US" smtClean="0"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48954-6B00-4698-A7A3-15599CD9A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9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251520" y="212289"/>
            <a:ext cx="7083243" cy="2599916"/>
            <a:chOff x="653988" y="2948030"/>
            <a:chExt cx="7083243" cy="2599916"/>
          </a:xfrm>
        </p:grpSpPr>
        <p:sp>
          <p:nvSpPr>
            <p:cNvPr id="5" name="正方形/長方形 4"/>
            <p:cNvSpPr/>
            <p:nvPr/>
          </p:nvSpPr>
          <p:spPr>
            <a:xfrm>
              <a:off x="653988" y="2948030"/>
              <a:ext cx="7083243" cy="2599916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" name="グループ化 5"/>
            <p:cNvGrpSpPr/>
            <p:nvPr/>
          </p:nvGrpSpPr>
          <p:grpSpPr>
            <a:xfrm>
              <a:off x="653988" y="2948030"/>
              <a:ext cx="4086823" cy="338554"/>
              <a:chOff x="653988" y="2948030"/>
              <a:chExt cx="4086823" cy="338554"/>
            </a:xfrm>
          </p:grpSpPr>
          <p:sp>
            <p:nvSpPr>
              <p:cNvPr id="8" name="テキスト ボックス 7"/>
              <p:cNvSpPr txBox="1"/>
              <p:nvPr/>
            </p:nvSpPr>
            <p:spPr>
              <a:xfrm>
                <a:off x="653988" y="2948030"/>
                <a:ext cx="53130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テキスト ボックス 8"/>
              <p:cNvSpPr txBox="1"/>
              <p:nvPr/>
            </p:nvSpPr>
            <p:spPr>
              <a:xfrm>
                <a:off x="4209504" y="2948030"/>
                <a:ext cx="53130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4" name="テキスト ボックス 13"/>
          <p:cNvSpPr txBox="1"/>
          <p:nvPr/>
        </p:nvSpPr>
        <p:spPr>
          <a:xfrm>
            <a:off x="490533" y="2816397"/>
            <a:ext cx="691276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050" b="1" dirty="0"/>
              <a:t>Figure </a:t>
            </a:r>
            <a:r>
              <a:rPr lang="en-GB" altLang="ja-JP" sz="1050" b="1" dirty="0" smtClean="0"/>
              <a:t>S1. </a:t>
            </a:r>
            <a:r>
              <a:rPr lang="en-GB" altLang="ja-JP" sz="1050" dirty="0"/>
              <a:t>Time courses of mycelial growth and pH changes in liquid cultures of </a:t>
            </a:r>
            <a:r>
              <a:rPr lang="en-GB" altLang="ja-JP" sz="1050" i="1" dirty="0" err="1"/>
              <a:t>Phlebia</a:t>
            </a:r>
            <a:r>
              <a:rPr lang="en-GB" altLang="ja-JP" sz="1050" i="1" dirty="0"/>
              <a:t> </a:t>
            </a:r>
            <a:r>
              <a:rPr lang="en-GB" altLang="ja-JP" sz="1050" dirty="0"/>
              <a:t>sp. MG-60 (A) and </a:t>
            </a:r>
            <a:r>
              <a:rPr lang="en-GB" altLang="ja-JP" sz="1050" i="1" dirty="0"/>
              <a:t>P. </a:t>
            </a:r>
            <a:r>
              <a:rPr lang="en-GB" altLang="ja-JP" sz="1050" i="1" dirty="0" err="1"/>
              <a:t>chrysosporium</a:t>
            </a:r>
            <a:r>
              <a:rPr lang="en-GB" altLang="ja-JP" sz="1050" dirty="0"/>
              <a:t> (B). </a:t>
            </a:r>
            <a:r>
              <a:rPr lang="en-GB" altLang="ja-JP" sz="1050" dirty="0" smtClean="0"/>
              <a:t>●</a:t>
            </a:r>
            <a:r>
              <a:rPr lang="en-GB" altLang="ja-JP" sz="1050" dirty="0"/>
              <a:t>: </a:t>
            </a:r>
            <a:r>
              <a:rPr lang="en-GB" altLang="ja-JP" sz="1050" dirty="0" smtClean="0"/>
              <a:t>mycelial growth ; </a:t>
            </a:r>
            <a:r>
              <a:rPr lang="en-GB" altLang="ja-JP" sz="1050" dirty="0"/>
              <a:t>○: </a:t>
            </a:r>
            <a:r>
              <a:rPr lang="en-GB" altLang="ja-JP" sz="1050" dirty="0" err="1" smtClean="0"/>
              <a:t>pH.</a:t>
            </a:r>
            <a:r>
              <a:rPr lang="en-GB" altLang="ja-JP" sz="1050" dirty="0" smtClean="0"/>
              <a:t> </a:t>
            </a:r>
            <a:r>
              <a:rPr lang="en-GB" altLang="ja-JP" sz="1050" dirty="0"/>
              <a:t>Values are the means ± SD of triplicate samples.</a:t>
            </a:r>
            <a:endParaRPr kumimoji="1" lang="ja-JP" altLang="en-US" sz="1050" dirty="0"/>
          </a:p>
        </p:txBody>
      </p:sp>
      <p:graphicFrame>
        <p:nvGraphicFramePr>
          <p:cNvPr id="15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2595247"/>
              </p:ext>
            </p:extLst>
          </p:nvPr>
        </p:nvGraphicFramePr>
        <p:xfrm>
          <a:off x="3793141" y="341342"/>
          <a:ext cx="3613629" cy="24708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6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7814975"/>
              </p:ext>
            </p:extLst>
          </p:nvPr>
        </p:nvGraphicFramePr>
        <p:xfrm>
          <a:off x="413510" y="427851"/>
          <a:ext cx="3379631" cy="2430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911067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74</Words>
  <Application>Microsoft Office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hiro</dc:creator>
  <cp:lastModifiedBy>tomohiro</cp:lastModifiedBy>
  <cp:revision>7</cp:revision>
  <dcterms:created xsi:type="dcterms:W3CDTF">2016-07-09T18:43:12Z</dcterms:created>
  <dcterms:modified xsi:type="dcterms:W3CDTF">2016-07-11T05:40:11Z</dcterms:modified>
</cp:coreProperties>
</file>